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73152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285920" y="685440"/>
            <a:ext cx="428616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DFD1BB3-3920-4AB3-82DF-29A5DDB5F7F5}" type="slidenum"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PlaceHolder 1"/>
          <p:cNvSpPr>
            <a:spLocks noGrp="1"/>
          </p:cNvSpPr>
          <p:nvPr>
            <p:ph type="sldImg"/>
          </p:nvPr>
        </p:nvSpPr>
        <p:spPr>
          <a:xfrm>
            <a:off x="1285920" y="685800"/>
            <a:ext cx="4286160" cy="3429000"/>
          </a:xfrm>
          <a:prstGeom prst="rect">
            <a:avLst/>
          </a:prstGeom>
          <a:ln w="0">
            <a:noFill/>
          </a:ln>
        </p:spPr>
      </p:sp>
      <p:sp>
        <p:nvSpPr>
          <p:cNvPr id="10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Calibri"/>
              <a:ea typeface="宋体"/>
            </a:endParaRPr>
          </a:p>
        </p:txBody>
      </p:sp>
      <p:sp>
        <p:nvSpPr>
          <p:cNvPr id="104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274642D-3D08-4BF3-B795-896632601E47}" type="slidenum"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DCD4FD-E7F7-4053-A0BD-04A6B19C298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93760"/>
            <a:ext cx="8229600" cy="1218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706400"/>
            <a:ext cx="82296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4228200"/>
            <a:ext cx="82296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9BD088-E3E8-4C5C-AE5F-F7BA2A25EE0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93760"/>
            <a:ext cx="8229600" cy="1218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706400"/>
            <a:ext cx="40158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706400"/>
            <a:ext cx="40158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4228200"/>
            <a:ext cx="40158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4228200"/>
            <a:ext cx="40158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D34215-D859-4AFF-B422-AE5A8E46130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93760"/>
            <a:ext cx="8229600" cy="1218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706400"/>
            <a:ext cx="26496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706400"/>
            <a:ext cx="26496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706400"/>
            <a:ext cx="26496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4228200"/>
            <a:ext cx="26496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4228200"/>
            <a:ext cx="26496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4228200"/>
            <a:ext cx="26496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0EC185-E183-45F3-BCEE-39A891A57CE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93760"/>
            <a:ext cx="8229600" cy="1218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706400"/>
            <a:ext cx="8229600" cy="4827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883180-69EF-4E45-9CD6-CBC9F0BEDE3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93760"/>
            <a:ext cx="8229600" cy="1218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706400"/>
            <a:ext cx="8229600" cy="4827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B4A842-B1E9-4FBD-9586-2AFD2B552C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93760"/>
            <a:ext cx="8229600" cy="1218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706400"/>
            <a:ext cx="4015800" cy="4827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706400"/>
            <a:ext cx="4015800" cy="4827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FBEFA2-00D8-460D-A7D3-CE75506148A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93760"/>
            <a:ext cx="8229600" cy="1218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C756F4-C67F-4D04-A100-0ABEE92E4A2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93760"/>
            <a:ext cx="8229600" cy="5651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3F3BE8-0EAA-4C73-91CF-4F85D2BFDD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93760"/>
            <a:ext cx="8229600" cy="1218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706400"/>
            <a:ext cx="40158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706400"/>
            <a:ext cx="4015800" cy="4827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4228200"/>
            <a:ext cx="40158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A1BE23-2142-43E7-92B0-7188B59338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93760"/>
            <a:ext cx="8229600" cy="1218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706400"/>
            <a:ext cx="4015800" cy="4827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706400"/>
            <a:ext cx="40158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4228200"/>
            <a:ext cx="40158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C1B295-0D32-4C22-9959-96D1185554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93760"/>
            <a:ext cx="8229600" cy="1218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706400"/>
            <a:ext cx="40158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706400"/>
            <a:ext cx="40158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4228200"/>
            <a:ext cx="8229600" cy="230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4460AD-230E-4199-BF0D-1A80DA3270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93760"/>
            <a:ext cx="8229600" cy="1218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706400"/>
            <a:ext cx="8229600" cy="4827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780240"/>
            <a:ext cx="2133720" cy="38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780240"/>
            <a:ext cx="2895840" cy="38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780240"/>
            <a:ext cx="2133720" cy="38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39812B2-C407-4321-A057-9391B10EF185}" type="slidenum">
              <a:rPr b="0" lang="en-US" sz="1200" spc="-1" strike="noStrike">
                <a:solidFill>
                  <a:srgbClr val="898989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2"/>
          <p:cNvGrpSpPr/>
          <p:nvPr/>
        </p:nvGrpSpPr>
        <p:grpSpPr>
          <a:xfrm>
            <a:off x="54000" y="457200"/>
            <a:ext cx="4060800" cy="4559400"/>
            <a:chOff x="54000" y="457200"/>
            <a:chExt cx="4060800" cy="4559400"/>
          </a:xfrm>
        </p:grpSpPr>
        <p:pic>
          <p:nvPicPr>
            <p:cNvPr id="49" name="Picture 2" descr=""/>
            <p:cNvPicPr/>
            <p:nvPr/>
          </p:nvPicPr>
          <p:blipFill>
            <a:blip r:embed="rId1"/>
            <a:srcRect l="0" t="4118" r="0" b="0"/>
            <a:stretch/>
          </p:blipFill>
          <p:spPr>
            <a:xfrm>
              <a:off x="831600" y="914400"/>
              <a:ext cx="1393920" cy="17762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50" name="Group 45"/>
            <p:cNvGrpSpPr/>
            <p:nvPr/>
          </p:nvGrpSpPr>
          <p:grpSpPr>
            <a:xfrm>
              <a:off x="54000" y="457200"/>
              <a:ext cx="4060800" cy="4559400"/>
              <a:chOff x="54000" y="457200"/>
              <a:chExt cx="4060800" cy="4559400"/>
            </a:xfrm>
          </p:grpSpPr>
          <p:grpSp>
            <p:nvGrpSpPr>
              <p:cNvPr id="51" name="Group 25"/>
              <p:cNvGrpSpPr/>
              <p:nvPr/>
            </p:nvGrpSpPr>
            <p:grpSpPr>
              <a:xfrm>
                <a:off x="54000" y="457200"/>
                <a:ext cx="4060800" cy="4559400"/>
                <a:chOff x="54000" y="457200"/>
                <a:chExt cx="4060800" cy="4559400"/>
              </a:xfrm>
            </p:grpSpPr>
            <p:sp>
              <p:nvSpPr>
                <p:cNvPr id="52" name="TextBox 5"/>
                <p:cNvSpPr/>
                <p:nvPr/>
              </p:nvSpPr>
              <p:spPr>
                <a:xfrm>
                  <a:off x="762840" y="457200"/>
                  <a:ext cx="315036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Arial"/>
                    </a:rPr>
                    <a:t>      </a:t>
                  </a:r>
                  <a:r>
                    <a:rPr b="0" lang="en-US" sz="1800" spc="-1" strike="noStrike">
                      <a:solidFill>
                        <a:srgbClr val="000000"/>
                      </a:solidFill>
                      <a:latin typeface="Arial"/>
                    </a:rPr>
                    <a:t>Basal                  Stim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" name="TextBox 6"/>
                <p:cNvSpPr/>
                <p:nvPr/>
              </p:nvSpPr>
              <p:spPr>
                <a:xfrm>
                  <a:off x="160920" y="992160"/>
                  <a:ext cx="7063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NR2B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54" name="Group 4"/>
                <p:cNvGrpSpPr/>
                <p:nvPr/>
              </p:nvGrpSpPr>
              <p:grpSpPr>
                <a:xfrm>
                  <a:off x="2392200" y="903240"/>
                  <a:ext cx="1722600" cy="4113360"/>
                  <a:chOff x="2392200" y="903240"/>
                  <a:chExt cx="1722600" cy="4113360"/>
                </a:xfrm>
              </p:grpSpPr>
              <p:pic>
                <p:nvPicPr>
                  <p:cNvPr id="55" name="Picture 74" descr=""/>
                  <p:cNvPicPr/>
                  <p:nvPr/>
                </p:nvPicPr>
                <p:blipFill>
                  <a:blip r:embed="rId2"/>
                  <a:srcRect l="0" t="1654" r="0" b="0"/>
                  <a:stretch/>
                </p:blipFill>
                <p:spPr>
                  <a:xfrm>
                    <a:off x="2392200" y="903240"/>
                    <a:ext cx="1722600" cy="4113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56" name="TextBox 57"/>
                  <p:cNvSpPr/>
                  <p:nvPr/>
                </p:nvSpPr>
                <p:spPr>
                  <a:xfrm>
                    <a:off x="2415600" y="1576080"/>
                    <a:ext cx="1524240" cy="33732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600" spc="-1" strike="noStrike">
                        <a:solidFill>
                          <a:srgbClr val="000000"/>
                        </a:solidFill>
                        <a:latin typeface="Arial"/>
                      </a:rPr>
                      <a:t>WT+MgT</a:t>
                    </a:r>
                    <a:endParaRPr b="0" lang="en-US" sz="1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7" name="Rounded Rectangle 101"/>
                  <p:cNvSpPr/>
                  <p:nvPr/>
                </p:nvSpPr>
                <p:spPr>
                  <a:xfrm>
                    <a:off x="2395440" y="903240"/>
                    <a:ext cx="228600" cy="304560"/>
                  </a:xfrm>
                  <a:custGeom>
                    <a:avLst/>
                    <a:gdLst>
                      <a:gd name="textAreaLeft" fmla="*/ 11160 w 228600"/>
                      <a:gd name="textAreaRight" fmla="*/ 217440 w 228600"/>
                      <a:gd name="textAreaTop" fmla="*/ 11160 h 304560"/>
                      <a:gd name="textAreaBottom" fmla="*/ 293400 h 304560"/>
                    </a:gdLst>
                    <a:ahLst/>
                    <a:rect l="textAreaLeft" t="textAreaTop" r="textAreaRight" b="textAreaBottom"/>
                    <a:pathLst>
                      <a:path w="21600" h="28766">
                        <a:moveTo>
                          <a:pt x="3600" y="0"/>
                        </a:moveTo>
                        <a:arcTo wR="3600" hR="3600" stAng="16200000" swAng="-5400000"/>
                        <a:lnTo>
                          <a:pt x="0" y="25166"/>
                        </a:lnTo>
                        <a:arcTo wR="3600" hR="3600" stAng="10800000" swAng="-5400000"/>
                        <a:lnTo>
                          <a:pt x="18000" y="28766"/>
                        </a:lnTo>
                        <a:arcTo wR="3600" hR="3600" stAng="5400000" swAng="-5400000"/>
                        <a:lnTo>
                          <a:pt x="21600" y="3600"/>
                        </a:lnTo>
                        <a:arcTo wR="3600" hR="3600" stAng="0" swAng="-5400000"/>
                        <a:close/>
                      </a:path>
                    </a:pathLst>
                  </a:custGeom>
                  <a:noFill/>
                  <a:ln w="25560">
                    <a:solidFill>
                      <a:srgbClr val="92d05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" name="Rounded Rectangle 104"/>
                  <p:cNvSpPr/>
                  <p:nvPr/>
                </p:nvSpPr>
                <p:spPr>
                  <a:xfrm>
                    <a:off x="2498760" y="2421000"/>
                    <a:ext cx="304560" cy="183960"/>
                  </a:xfrm>
                  <a:prstGeom prst="roundRect">
                    <a:avLst>
                      <a:gd name="adj" fmla="val 16667"/>
                    </a:avLst>
                  </a:prstGeom>
                  <a:noFill/>
                  <a:ln w="25560">
                    <a:solidFill>
                      <a:srgbClr val="92d05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" name="Rounded Rectangle 106"/>
                  <p:cNvSpPr/>
                  <p:nvPr/>
                </p:nvSpPr>
                <p:spPr>
                  <a:xfrm>
                    <a:off x="2471760" y="3237120"/>
                    <a:ext cx="225360" cy="250560"/>
                  </a:xfrm>
                  <a:custGeom>
                    <a:avLst/>
                    <a:gdLst>
                      <a:gd name="textAreaLeft" fmla="*/ 10800 w 225360"/>
                      <a:gd name="textAreaRight" fmla="*/ 214560 w 225360"/>
                      <a:gd name="textAreaTop" fmla="*/ 10800 h 250560"/>
                      <a:gd name="textAreaBottom" fmla="*/ 239760 h 250560"/>
                    </a:gdLst>
                    <a:ahLst/>
                    <a:rect l="textAreaLeft" t="textAreaTop" r="textAreaRight" b="textAreaBottom"/>
                    <a:pathLst>
                      <a:path w="21600" h="24011">
                        <a:moveTo>
                          <a:pt x="3600" y="0"/>
                        </a:moveTo>
                        <a:arcTo wR="3600" hR="3600" stAng="16200000" swAng="-5400000"/>
                        <a:lnTo>
                          <a:pt x="0" y="20411"/>
                        </a:lnTo>
                        <a:arcTo wR="3600" hR="3600" stAng="10800000" swAng="-5400000"/>
                        <a:lnTo>
                          <a:pt x="18000" y="24011"/>
                        </a:lnTo>
                        <a:arcTo wR="3600" hR="3600" stAng="5400000" swAng="-5400000"/>
                        <a:lnTo>
                          <a:pt x="21600" y="3600"/>
                        </a:lnTo>
                        <a:arcTo wR="3600" hR="3600" stAng="0" swAng="-5400000"/>
                        <a:close/>
                      </a:path>
                    </a:pathLst>
                  </a:custGeom>
                  <a:noFill/>
                  <a:ln w="25560">
                    <a:solidFill>
                      <a:srgbClr val="92d05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" name="Rounded Rectangle 108"/>
                  <p:cNvSpPr/>
                  <p:nvPr/>
                </p:nvSpPr>
                <p:spPr>
                  <a:xfrm>
                    <a:off x="2567160" y="4672080"/>
                    <a:ext cx="282240" cy="199800"/>
                  </a:xfrm>
                  <a:prstGeom prst="roundRect">
                    <a:avLst>
                      <a:gd name="adj" fmla="val 16667"/>
                    </a:avLst>
                  </a:prstGeom>
                  <a:noFill/>
                  <a:ln w="25560">
                    <a:solidFill>
                      <a:srgbClr val="92d05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61" name="TextBox 6"/>
                <p:cNvSpPr/>
                <p:nvPr/>
              </p:nvSpPr>
              <p:spPr>
                <a:xfrm>
                  <a:off x="54000" y="2465640"/>
                  <a:ext cx="8136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GAPDH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" name="TextBox 6"/>
                <p:cNvSpPr/>
                <p:nvPr/>
              </p:nvSpPr>
              <p:spPr>
                <a:xfrm>
                  <a:off x="140400" y="3223800"/>
                  <a:ext cx="7063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NR2B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" name="TextBox 6"/>
                <p:cNvSpPr/>
                <p:nvPr/>
              </p:nvSpPr>
              <p:spPr>
                <a:xfrm>
                  <a:off x="129960" y="4699800"/>
                  <a:ext cx="8136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GAPDH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64" name="Group 24"/>
                <p:cNvGrpSpPr/>
                <p:nvPr/>
              </p:nvGrpSpPr>
              <p:grpSpPr>
                <a:xfrm>
                  <a:off x="858600" y="1207440"/>
                  <a:ext cx="1329120" cy="3769200"/>
                  <a:chOff x="858600" y="1207440"/>
                  <a:chExt cx="1329120" cy="3769200"/>
                </a:xfrm>
              </p:grpSpPr>
              <p:pic>
                <p:nvPicPr>
                  <p:cNvPr id="65" name="Picture 3" descr="E:\AD paper\论文\AD paper fig all\黄娴小鼠WB\western\bace1&amp;nr2b WB\20120824-WT-2.bmp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858600" y="3237120"/>
                    <a:ext cx="1329120" cy="1739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66" name="TextBox 57"/>
                  <p:cNvSpPr/>
                  <p:nvPr/>
                </p:nvSpPr>
                <p:spPr>
                  <a:xfrm>
                    <a:off x="910440" y="1623600"/>
                    <a:ext cx="1234800" cy="33732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GB" sz="1600" spc="-1" strike="noStrike">
                        <a:solidFill>
                          <a:srgbClr val="000000"/>
                        </a:solidFill>
                        <a:latin typeface="Arial"/>
                      </a:rPr>
                      <a:t>WT+MgT</a:t>
                    </a:r>
                    <a:endParaRPr b="0" lang="en-US" sz="1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7" name="TextBox 57"/>
                  <p:cNvSpPr/>
                  <p:nvPr/>
                </p:nvSpPr>
                <p:spPr>
                  <a:xfrm>
                    <a:off x="952920" y="3952440"/>
                    <a:ext cx="1176840" cy="33732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600" spc="-1" strike="noStrike">
                        <a:solidFill>
                          <a:srgbClr val="000000"/>
                        </a:solidFill>
                        <a:latin typeface="Arial"/>
                      </a:rPr>
                      <a:t>WT</a:t>
                    </a:r>
                    <a:endParaRPr b="0" lang="en-US" sz="1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cxnSp>
                <p:nvCxnSpPr>
                  <p:cNvPr id="68" name="Straight Arrow Connector 8"/>
                  <p:cNvCxnSpPr>
                    <a:stCxn id="66" idx="0"/>
                  </p:cNvCxnSpPr>
                  <p:nvPr/>
                </p:nvCxnSpPr>
                <p:spPr>
                  <a:xfrm flipH="1" flipV="1">
                    <a:off x="1526400" y="1207440"/>
                    <a:ext cx="1800" cy="416520"/>
                  </a:xfrm>
                  <a:prstGeom prst="straightConnector1">
                    <a:avLst/>
                  </a:prstGeom>
                  <a:ln w="9360">
                    <a:solidFill>
                      <a:srgbClr val="4a7ebb"/>
                    </a:solidFill>
                    <a:miter/>
                    <a:tailEnd len="med" type="arrow" w="med"/>
                  </a:ln>
                </p:spPr>
              </p:cxnSp>
              <p:cxnSp>
                <p:nvCxnSpPr>
                  <p:cNvPr id="69" name="Straight Arrow Connector 10"/>
                  <p:cNvCxnSpPr/>
                  <p:nvPr/>
                </p:nvCxnSpPr>
                <p:spPr>
                  <a:xfrm flipH="1">
                    <a:off x="1559880" y="1962000"/>
                    <a:ext cx="5400" cy="459360"/>
                  </a:xfrm>
                  <a:prstGeom prst="straightConnector1">
                    <a:avLst/>
                  </a:prstGeom>
                  <a:ln w="9360">
                    <a:solidFill>
                      <a:srgbClr val="4a7ebb"/>
                    </a:solidFill>
                    <a:miter/>
                    <a:tailEnd len="med" type="arrow" w="med"/>
                  </a:ln>
                </p:spPr>
              </p:cxnSp>
              <p:cxnSp>
                <p:nvCxnSpPr>
                  <p:cNvPr id="70" name="Straight Arrow Connector 21"/>
                  <p:cNvCxnSpPr>
                    <a:stCxn id="67" idx="0"/>
                  </p:cNvCxnSpPr>
                  <p:nvPr/>
                </p:nvCxnSpPr>
                <p:spPr>
                  <a:xfrm flipV="1">
                    <a:off x="1541160" y="3446280"/>
                    <a:ext cx="19800" cy="506520"/>
                  </a:xfrm>
                  <a:prstGeom prst="straightConnector1">
                    <a:avLst/>
                  </a:prstGeom>
                  <a:ln w="9360">
                    <a:solidFill>
                      <a:srgbClr val="4a7ebb"/>
                    </a:solidFill>
                    <a:miter/>
                    <a:tailEnd len="med" type="arrow" w="med"/>
                  </a:ln>
                </p:spPr>
              </p:cxnSp>
              <p:cxnSp>
                <p:nvCxnSpPr>
                  <p:cNvPr id="71" name="Straight Arrow Connector 23"/>
                  <p:cNvCxnSpPr/>
                  <p:nvPr/>
                </p:nvCxnSpPr>
                <p:spPr>
                  <a:xfrm>
                    <a:off x="1549440" y="4291200"/>
                    <a:ext cx="11520" cy="481680"/>
                  </a:xfrm>
                  <a:prstGeom prst="straightConnector1">
                    <a:avLst/>
                  </a:prstGeom>
                  <a:ln w="9360">
                    <a:solidFill>
                      <a:srgbClr val="4a7ebb"/>
                    </a:solidFill>
                    <a:miter/>
                    <a:tailEnd len="med" type="arrow" w="med"/>
                  </a:ln>
                </p:spPr>
              </p:cxnSp>
              <p:sp>
                <p:nvSpPr>
                  <p:cNvPr id="72" name="Rounded Rectangle 148"/>
                  <p:cNvSpPr/>
                  <p:nvPr/>
                </p:nvSpPr>
                <p:spPr>
                  <a:xfrm>
                    <a:off x="1824120" y="3237120"/>
                    <a:ext cx="287280" cy="215640"/>
                  </a:xfrm>
                  <a:prstGeom prst="roundRect">
                    <a:avLst>
                      <a:gd name="adj" fmla="val 16667"/>
                    </a:avLst>
                  </a:prstGeom>
                  <a:noFill/>
                  <a:ln w="25560">
                    <a:solidFill>
                      <a:srgbClr val="00b05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3" name="Rounded Rectangle 149"/>
                  <p:cNvSpPr/>
                  <p:nvPr/>
                </p:nvSpPr>
                <p:spPr>
                  <a:xfrm>
                    <a:off x="1845000" y="4699440"/>
                    <a:ext cx="228600" cy="250560"/>
                  </a:xfrm>
                  <a:custGeom>
                    <a:avLst/>
                    <a:gdLst>
                      <a:gd name="textAreaLeft" fmla="*/ 11160 w 228600"/>
                      <a:gd name="textAreaRight" fmla="*/ 217440 w 228600"/>
                      <a:gd name="textAreaTop" fmla="*/ 11160 h 250560"/>
                      <a:gd name="textAreaBottom" fmla="*/ 239400 h 250560"/>
                    </a:gdLst>
                    <a:ahLst/>
                    <a:rect l="textAreaLeft" t="textAreaTop" r="textAreaRight" b="textAreaBottom"/>
                    <a:pathLst>
                      <a:path w="21600" h="23672">
                        <a:moveTo>
                          <a:pt x="3600" y="0"/>
                        </a:moveTo>
                        <a:arcTo wR="3600" hR="3600" stAng="16200000" swAng="-5400000"/>
                        <a:lnTo>
                          <a:pt x="0" y="20072"/>
                        </a:lnTo>
                        <a:arcTo wR="3600" hR="3600" stAng="10800000" swAng="-5400000"/>
                        <a:lnTo>
                          <a:pt x="18000" y="23672"/>
                        </a:lnTo>
                        <a:arcTo wR="3600" hR="3600" stAng="5400000" swAng="-5400000"/>
                        <a:lnTo>
                          <a:pt x="21600" y="3600"/>
                        </a:lnTo>
                        <a:arcTo wR="3600" hR="3600" stAng="0" swAng="-5400000"/>
                        <a:close/>
                      </a:path>
                    </a:pathLst>
                  </a:custGeom>
                  <a:noFill/>
                  <a:ln w="25560">
                    <a:solidFill>
                      <a:srgbClr val="00b05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cxnSp>
            <p:nvCxnSpPr>
              <p:cNvPr id="74" name="Straight Arrow Connector 12"/>
              <p:cNvCxnSpPr>
                <a:stCxn id="56" idx="0"/>
              </p:cNvCxnSpPr>
              <p:nvPr/>
            </p:nvCxnSpPr>
            <p:spPr>
              <a:xfrm flipV="1">
                <a:off x="3177720" y="1205640"/>
                <a:ext cx="1440" cy="370800"/>
              </a:xfrm>
              <a:prstGeom prst="straightConnector1">
                <a:avLst/>
              </a:prstGeom>
              <a:ln w="9360">
                <a:solidFill>
                  <a:srgbClr val="4a7ebb"/>
                </a:solidFill>
                <a:miter/>
                <a:tailEnd len="med" type="arrow" w="med"/>
              </a:ln>
            </p:spPr>
          </p:cxnSp>
          <p:cxnSp>
            <p:nvCxnSpPr>
              <p:cNvPr id="75" name="Straight Arrow Connector 14"/>
              <p:cNvCxnSpPr/>
              <p:nvPr/>
            </p:nvCxnSpPr>
            <p:spPr>
              <a:xfrm>
                <a:off x="3207960" y="1908000"/>
                <a:ext cx="1080" cy="421200"/>
              </a:xfrm>
              <a:prstGeom prst="straightConnector1">
                <a:avLst/>
              </a:prstGeom>
              <a:ln w="9360">
                <a:solidFill>
                  <a:srgbClr val="4a7ebb"/>
                </a:solidFill>
                <a:miter/>
                <a:tailEnd len="med" type="arrow" w="med"/>
              </a:ln>
            </p:spPr>
          </p:cxnSp>
          <p:sp>
            <p:nvSpPr>
              <p:cNvPr id="76" name="TextBox 57"/>
              <p:cNvSpPr/>
              <p:nvPr/>
            </p:nvSpPr>
            <p:spPr>
              <a:xfrm>
                <a:off x="2566800" y="3758400"/>
                <a:ext cx="1526040" cy="3373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77" name="Straight Arrow Connector 16"/>
              <p:cNvCxnSpPr>
                <a:stCxn id="76" idx="0"/>
              </p:cNvCxnSpPr>
              <p:nvPr/>
            </p:nvCxnSpPr>
            <p:spPr>
              <a:xfrm flipH="1" flipV="1">
                <a:off x="3295440" y="3387240"/>
                <a:ext cx="34560" cy="371520"/>
              </a:xfrm>
              <a:prstGeom prst="straightConnector1">
                <a:avLst/>
              </a:prstGeom>
              <a:ln w="9360">
                <a:solidFill>
                  <a:srgbClr val="4a7ebb"/>
                </a:solidFill>
                <a:miter/>
                <a:tailEnd len="med" type="arrow" w="med"/>
              </a:ln>
            </p:spPr>
          </p:cxnSp>
          <p:cxnSp>
            <p:nvCxnSpPr>
              <p:cNvPr id="78" name="Straight Arrow Connector 18"/>
              <p:cNvCxnSpPr>
                <a:stCxn id="76" idx="2"/>
              </p:cNvCxnSpPr>
              <p:nvPr/>
            </p:nvCxnSpPr>
            <p:spPr>
              <a:xfrm flipH="1">
                <a:off x="3295440" y="4095720"/>
                <a:ext cx="34560" cy="478440"/>
              </a:xfrm>
              <a:prstGeom prst="straightConnector1">
                <a:avLst/>
              </a:prstGeom>
              <a:ln w="9360">
                <a:solidFill>
                  <a:srgbClr val="4a7ebb"/>
                </a:solidFill>
                <a:miter/>
                <a:tailEnd len="med" type="arrow" w="med"/>
              </a:ln>
            </p:spPr>
          </p:cxnSp>
        </p:grpSp>
        <p:sp>
          <p:nvSpPr>
            <p:cNvPr id="79" name="Rounded Rectangle 56"/>
            <p:cNvSpPr/>
            <p:nvPr/>
          </p:nvSpPr>
          <p:spPr>
            <a:xfrm>
              <a:off x="1808280" y="914400"/>
              <a:ext cx="287280" cy="215640"/>
            </a:xfrm>
            <a:prstGeom prst="roundRect">
              <a:avLst>
                <a:gd name="adj" fmla="val 16667"/>
              </a:avLst>
            </a:prstGeom>
            <a:noFill/>
            <a:ln w="25560">
              <a:solidFill>
                <a:srgbClr val="00b05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ounded Rectangle 57"/>
            <p:cNvSpPr/>
            <p:nvPr/>
          </p:nvSpPr>
          <p:spPr>
            <a:xfrm>
              <a:off x="1959120" y="2425680"/>
              <a:ext cx="287280" cy="215640"/>
            </a:xfrm>
            <a:prstGeom prst="roundRect">
              <a:avLst>
                <a:gd name="adj" fmla="val 16667"/>
              </a:avLst>
            </a:prstGeom>
            <a:noFill/>
            <a:ln w="25560">
              <a:solidFill>
                <a:srgbClr val="00b05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1" name="TextBox 58"/>
          <p:cNvSpPr/>
          <p:nvPr/>
        </p:nvSpPr>
        <p:spPr>
          <a:xfrm>
            <a:off x="228600" y="6507000"/>
            <a:ext cx="137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2" name="Group 2"/>
          <p:cNvGrpSpPr/>
          <p:nvPr/>
        </p:nvGrpSpPr>
        <p:grpSpPr>
          <a:xfrm>
            <a:off x="4419720" y="457200"/>
            <a:ext cx="4132080" cy="4413600"/>
            <a:chOff x="4419720" y="457200"/>
            <a:chExt cx="4132080" cy="4413600"/>
          </a:xfrm>
        </p:grpSpPr>
        <p:sp>
          <p:nvSpPr>
            <p:cNvPr id="83" name="TextBox 60"/>
            <p:cNvSpPr/>
            <p:nvPr/>
          </p:nvSpPr>
          <p:spPr>
            <a:xfrm>
              <a:off x="4495680" y="1441440"/>
              <a:ext cx="706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BACE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Box 61"/>
            <p:cNvSpPr/>
            <p:nvPr/>
          </p:nvSpPr>
          <p:spPr>
            <a:xfrm>
              <a:off x="4443480" y="2171520"/>
              <a:ext cx="966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GAPD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Box 63"/>
            <p:cNvSpPr/>
            <p:nvPr/>
          </p:nvSpPr>
          <p:spPr>
            <a:xfrm>
              <a:off x="4471920" y="3864240"/>
              <a:ext cx="706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BACE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Box 64"/>
            <p:cNvSpPr/>
            <p:nvPr/>
          </p:nvSpPr>
          <p:spPr>
            <a:xfrm>
              <a:off x="4419720" y="4594320"/>
              <a:ext cx="966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GAPD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7" name="Group 1"/>
            <p:cNvGrpSpPr/>
            <p:nvPr/>
          </p:nvGrpSpPr>
          <p:grpSpPr>
            <a:xfrm>
              <a:off x="5105520" y="457200"/>
              <a:ext cx="3446280" cy="4337280"/>
              <a:chOff x="5105520" y="457200"/>
              <a:chExt cx="3446280" cy="4337280"/>
            </a:xfrm>
          </p:grpSpPr>
          <p:pic>
            <p:nvPicPr>
              <p:cNvPr id="88" name="Picture 4" descr=""/>
              <p:cNvPicPr/>
              <p:nvPr/>
            </p:nvPicPr>
            <p:blipFill>
              <a:blip r:embed="rId4"/>
              <a:stretch/>
            </p:blipFill>
            <p:spPr>
              <a:xfrm>
                <a:off x="5105520" y="1292040"/>
                <a:ext cx="3446280" cy="35024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9" name="TextBox 5"/>
              <p:cNvSpPr/>
              <p:nvPr/>
            </p:nvSpPr>
            <p:spPr>
              <a:xfrm>
                <a:off x="5221080" y="457200"/>
                <a:ext cx="31496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      </a:t>
                </a: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Basal                  Stim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TextBox 57"/>
              <p:cNvSpPr/>
              <p:nvPr/>
            </p:nvSpPr>
            <p:spPr>
              <a:xfrm>
                <a:off x="5199120" y="2813040"/>
                <a:ext cx="3287880" cy="5814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400" spc="-1" strike="noStrike">
                    <a:solidFill>
                      <a:srgbClr val="000000"/>
                    </a:solidFill>
                    <a:latin typeface="Arial"/>
                  </a:rPr>
                  <a:t>     </a:t>
                </a: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r>
                  <a:rPr b="0" lang="en-US" sz="3200" spc="-1" strike="noStrike">
                    <a:solidFill>
                      <a:srgbClr val="000000"/>
                    </a:solidFill>
                    <a:latin typeface="Arial"/>
                  </a:rPr>
                  <a:t>            </a:t>
                </a: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TextBox 58"/>
              <p:cNvSpPr/>
              <p:nvPr/>
            </p:nvSpPr>
            <p:spPr>
              <a:xfrm>
                <a:off x="5342760" y="834840"/>
                <a:ext cx="29718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WT+MgT            WT+MgT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Rounded Rectangle 71"/>
              <p:cNvSpPr/>
              <p:nvPr/>
            </p:nvSpPr>
            <p:spPr>
              <a:xfrm>
                <a:off x="5691240" y="1455840"/>
                <a:ext cx="228600" cy="250560"/>
              </a:xfrm>
              <a:custGeom>
                <a:avLst/>
                <a:gdLst>
                  <a:gd name="textAreaLeft" fmla="*/ 11160 w 228600"/>
                  <a:gd name="textAreaRight" fmla="*/ 217440 w 228600"/>
                  <a:gd name="textAreaTop" fmla="*/ 11160 h 250560"/>
                  <a:gd name="textAreaBottom" fmla="*/ 239400 h 250560"/>
                </a:gdLst>
                <a:ahLst/>
                <a:rect l="textAreaLeft" t="textAreaTop" r="textAreaRight" b="textAreaBottom"/>
                <a:pathLst>
                  <a:path w="21600" h="23672">
                    <a:moveTo>
                      <a:pt x="3600" y="0"/>
                    </a:moveTo>
                    <a:arcTo wR="3600" hR="3600" stAng="16200000" swAng="-5400000"/>
                    <a:lnTo>
                      <a:pt x="0" y="20072"/>
                    </a:lnTo>
                    <a:arcTo wR="3600" hR="3600" stAng="10800000" swAng="-5400000"/>
                    <a:lnTo>
                      <a:pt x="18000" y="23672"/>
                    </a:lnTo>
                    <a:arcTo wR="3600" hR="3600" stAng="5400000" swAng="-5400000"/>
                    <a:lnTo>
                      <a:pt x="21600" y="3600"/>
                    </a:lnTo>
                    <a:arcTo wR="3600" hR="3600" stAng="0" swAng="-5400000"/>
                    <a:close/>
                  </a:path>
                </a:pathLst>
              </a:custGeom>
              <a:noFill/>
              <a:ln w="25560">
                <a:solidFill>
                  <a:srgbClr val="00b05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Rounded Rectangle 72"/>
              <p:cNvSpPr/>
              <p:nvPr/>
            </p:nvSpPr>
            <p:spPr>
              <a:xfrm>
                <a:off x="5746680" y="2205000"/>
                <a:ext cx="228600" cy="230040"/>
              </a:xfrm>
              <a:custGeom>
                <a:avLst/>
                <a:gdLst>
                  <a:gd name="textAreaLeft" fmla="*/ 11160 w 228600"/>
                  <a:gd name="textAreaRight" fmla="*/ 217440 w 228600"/>
                  <a:gd name="textAreaTop" fmla="*/ 11160 h 230040"/>
                  <a:gd name="textAreaBottom" fmla="*/ 218880 h 230040"/>
                </a:gdLst>
                <a:ahLst/>
                <a:rect l="textAreaLeft" t="textAreaTop" r="textAreaRight" b="textAreaBottom"/>
                <a:pathLst>
                  <a:path w="21600" h="21736">
                    <a:moveTo>
                      <a:pt x="3600" y="0"/>
                    </a:moveTo>
                    <a:arcTo wR="3600" hR="3600" stAng="16200000" swAng="-5400000"/>
                    <a:lnTo>
                      <a:pt x="0" y="18136"/>
                    </a:lnTo>
                    <a:arcTo wR="3600" hR="3600" stAng="10800000" swAng="-5400000"/>
                    <a:lnTo>
                      <a:pt x="18000" y="21736"/>
                    </a:lnTo>
                    <a:arcTo wR="3600" hR="3600" stAng="5400000" swAng="-5400000"/>
                    <a:lnTo>
                      <a:pt x="21600" y="3600"/>
                    </a:lnTo>
                    <a:arcTo wR="3600" hR="3600" stAng="0" swAng="-5400000"/>
                    <a:close/>
                  </a:path>
                </a:pathLst>
              </a:custGeom>
              <a:noFill/>
              <a:ln w="25560">
                <a:solidFill>
                  <a:srgbClr val="00b05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Rounded Rectangle 73"/>
              <p:cNvSpPr/>
              <p:nvPr/>
            </p:nvSpPr>
            <p:spPr>
              <a:xfrm>
                <a:off x="5278320" y="3792960"/>
                <a:ext cx="304560" cy="274320"/>
              </a:xfrm>
              <a:prstGeom prst="roundRect">
                <a:avLst>
                  <a:gd name="adj" fmla="val 16667"/>
                </a:avLst>
              </a:prstGeom>
              <a:noFill/>
              <a:ln w="25560">
                <a:solidFill>
                  <a:srgbClr val="00b05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Rounded Rectangle 74"/>
              <p:cNvSpPr/>
              <p:nvPr/>
            </p:nvSpPr>
            <p:spPr>
              <a:xfrm>
                <a:off x="5257800" y="4583520"/>
                <a:ext cx="325440" cy="145800"/>
              </a:xfrm>
              <a:prstGeom prst="roundRect">
                <a:avLst>
                  <a:gd name="adj" fmla="val 16667"/>
                </a:avLst>
              </a:prstGeom>
              <a:noFill/>
              <a:ln w="25560">
                <a:solidFill>
                  <a:srgbClr val="00b05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Rounded Rectangle 75"/>
              <p:cNvSpPr/>
              <p:nvPr/>
            </p:nvSpPr>
            <p:spPr>
              <a:xfrm>
                <a:off x="6858000" y="1353960"/>
                <a:ext cx="304560" cy="304560"/>
              </a:xfrm>
              <a:prstGeom prst="roundRect">
                <a:avLst>
                  <a:gd name="adj" fmla="val 16667"/>
                </a:avLst>
              </a:prstGeom>
              <a:noFill/>
              <a:ln w="25560">
                <a:solidFill>
                  <a:srgbClr val="92d05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Rounded Rectangle 76"/>
              <p:cNvSpPr/>
              <p:nvPr/>
            </p:nvSpPr>
            <p:spPr>
              <a:xfrm>
                <a:off x="6934320" y="2160720"/>
                <a:ext cx="304560" cy="183960"/>
              </a:xfrm>
              <a:prstGeom prst="roundRect">
                <a:avLst>
                  <a:gd name="adj" fmla="val 16667"/>
                </a:avLst>
              </a:prstGeom>
              <a:noFill/>
              <a:ln w="25560">
                <a:solidFill>
                  <a:srgbClr val="92d05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Rounded Rectangle 77"/>
              <p:cNvSpPr/>
              <p:nvPr/>
            </p:nvSpPr>
            <p:spPr>
              <a:xfrm>
                <a:off x="6934320" y="3640320"/>
                <a:ext cx="304560" cy="250560"/>
              </a:xfrm>
              <a:prstGeom prst="roundRect">
                <a:avLst>
                  <a:gd name="adj" fmla="val 16667"/>
                </a:avLst>
              </a:prstGeom>
              <a:noFill/>
              <a:ln w="25560">
                <a:solidFill>
                  <a:srgbClr val="92d05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Rounded Rectangle 78"/>
              <p:cNvSpPr/>
              <p:nvPr/>
            </p:nvSpPr>
            <p:spPr>
              <a:xfrm>
                <a:off x="7010280" y="4456440"/>
                <a:ext cx="304560" cy="199800"/>
              </a:xfrm>
              <a:prstGeom prst="roundRect">
                <a:avLst>
                  <a:gd name="adj" fmla="val 16667"/>
                </a:avLst>
              </a:prstGeom>
              <a:noFill/>
              <a:ln w="25560">
                <a:solidFill>
                  <a:srgbClr val="92d05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00" name="TextBox 79"/>
          <p:cNvSpPr/>
          <p:nvPr/>
        </p:nvSpPr>
        <p:spPr>
          <a:xfrm>
            <a:off x="185760" y="122400"/>
            <a:ext cx="423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Box 80"/>
          <p:cNvSpPr/>
          <p:nvPr/>
        </p:nvSpPr>
        <p:spPr>
          <a:xfrm>
            <a:off x="4529160" y="122400"/>
            <a:ext cx="423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18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4-27T06:42:39Z</dcterms:created>
  <dc:creator>guosong</dc:creator>
  <dc:description/>
  <dc:language>en-US</dc:language>
  <cp:lastModifiedBy>Vivien Li</cp:lastModifiedBy>
  <dcterms:modified xsi:type="dcterms:W3CDTF">2014-08-20T17:41:57Z</dcterms:modified>
  <cp:revision>274</cp:revision>
  <dc:subject/>
  <dc:title>PowerPoint Presentation</dc:title>
</cp:coreProperties>
</file>